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0"/>
    <p:restoredTop sz="94663"/>
  </p:normalViewPr>
  <p:slideViewPr>
    <p:cSldViewPr snapToGrid="0" snapToObjects="1">
      <p:cViewPr varScale="1">
        <p:scale>
          <a:sx n="115" d="100"/>
          <a:sy n="115" d="100"/>
        </p:scale>
        <p:origin x="396" y="-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9506CD-F92B-B149-9090-C80B63B4E5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4CAA89-86E6-A94E-A238-F251831CF1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6EF5CA-1F8D-9A44-87DC-8BB31EFA2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B03269-EE2B-1B42-BF7F-22366DCCF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763445-D31C-FD4E-ADDF-0626C29BD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220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EC56A5-1F66-F240-8E23-A5BE721661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118BF8-BCFF-5647-9199-9F8297B523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409A22-0795-3B46-9D60-75B74E8CD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A1446F-FE97-1D4F-B544-00F8C7FE19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9D2D8D-ADD4-4540-8E04-26DA9A357E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981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4059024-A2CA-A44D-9D84-C317BCBFF6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7F1345-8785-B14B-BAF9-CC1CCD7B4F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1C82CC-35B3-684E-A9AA-7ACAB5542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BC78F0-C09D-794D-ADD3-49BEEE804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3F7ED2-768A-A344-9EB9-E06F881A8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452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C24A38-CF37-0249-9686-1A7A51CA1C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CEFCFD-B1E6-CB43-A0E3-612C89AC67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C1E4C6-135B-2C47-96DE-8D075F362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8EE4FD-80E2-A04D-9D26-CA0CEEF08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F3F651-338A-F645-B728-CFEC17F69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137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90FE4B-B164-C64A-A310-6AABC94979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D85444-3F3D-4444-ABA8-C901AF38C2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CCD4F6-3FD2-214A-B6CD-3DE74487F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BC075E-6A3E-C341-BAFC-944C63B90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88042A-B40F-B74B-9E1C-621A92F56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449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93D94-5DC3-3140-B34F-BE5E89539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8B4600-ED1D-7F4A-9E96-7D20DD642D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F27615-105E-E548-A96A-FE8E6B88A4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C4432D-E8A7-3A46-8383-89AD91253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F93A36-3FB4-1043-9E67-0E6AA60AD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C0609A-62FC-0C44-B5D8-39300D2C6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281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2609CD-1316-9E4C-B0DE-0074400F51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7C19DE-34A2-334F-80C1-7E6396289D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7DAEDD-D49E-D344-A95E-4391C5283B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2ECD91-8A6D-7F41-B5FF-D8515CC2D7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1BB2FA-AC01-4C4B-AD48-43C5D83203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D5E9DC-C122-0143-B741-30FD6B725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2A8076-9374-9D41-BC07-0938415D5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839887-1511-8246-8948-007D6534B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089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6117E-975C-C34F-A977-3BFCD0DF5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BA5795-AEE5-924D-B880-B3DB1FED6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B113DE-776D-CB44-B356-2E8B6EB80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F8680E-9113-FA4E-AC13-38657D027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940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CF77EA-02FE-2044-B3C6-5D4B213E7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A2EB0A-A58F-AA40-AED0-9A7BCFE1F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B6F5EA-26B7-E74F-A34C-A3583764A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383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D8FCE7-8080-B847-B1BB-20758469C4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EAB6CE-DA5A-A147-8543-B9DFC07667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94E9D5-7B8E-1543-BD55-A2795E4FEF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621751-455E-4648-B9E6-1EDE6041B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2091A1-3902-7B47-BA97-9977700BB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517FB5-A5F9-B349-B581-EB3D45BD4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615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A1DB22-F343-104C-9C65-3BC47DED8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70BE81-74D5-1949-97CB-F35F2D2AB5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EB90E9-7420-4F44-9C02-BA48DD3CB1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1D666E-40EB-244A-888A-443F9FD9C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A3BF9C-7A5C-2841-8AC6-510AE7870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EADD82-A658-9640-A30D-30B4E3B46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013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CB9AE34-62B1-2C40-9B8E-7D3B487972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EE69FC-49B6-9141-96AE-30773A05BF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25C62A-877F-374D-A283-2CEFA1FFCA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0FD05-9C34-004C-A00F-62F5C5CAA738}" type="datetimeFigureOut">
              <a:rPr lang="en-US" smtClean="0"/>
              <a:t>7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CE4560-FD0C-0144-8D7A-03A2197443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AE13E9-DBE0-8D49-9495-74BFAB5C63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C7E62-85DE-A541-8231-D05BBD0EE6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80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002D922-FAA5-C24A-8AB3-12AD23AA53F3}"/>
              </a:ext>
            </a:extLst>
          </p:cNvPr>
          <p:cNvSpPr txBox="1"/>
          <p:nvPr/>
        </p:nvSpPr>
        <p:spPr>
          <a:xfrm>
            <a:off x="1609706" y="223159"/>
            <a:ext cx="294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84BC6C-8158-0B46-AD46-C3FA7083AF72}"/>
              </a:ext>
            </a:extLst>
          </p:cNvPr>
          <p:cNvSpPr txBox="1"/>
          <p:nvPr/>
        </p:nvSpPr>
        <p:spPr>
          <a:xfrm>
            <a:off x="4639498" y="4648015"/>
            <a:ext cx="47401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EA2356-B14C-D54E-86D2-34E320E7A8BC}"/>
              </a:ext>
            </a:extLst>
          </p:cNvPr>
          <p:cNvSpPr txBox="1"/>
          <p:nvPr/>
        </p:nvSpPr>
        <p:spPr>
          <a:xfrm>
            <a:off x="6368143" y="223159"/>
            <a:ext cx="239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E7CD9B5-32CD-734E-AA4D-A488A845DC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4674" y="484184"/>
            <a:ext cx="3824841" cy="358906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B45531A-EEB7-BB43-8F1F-510388E873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98434" y="484184"/>
            <a:ext cx="2846308" cy="3320693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55284A43-14EC-5349-B64A-C29A2944D6BB}"/>
              </a:ext>
            </a:extLst>
          </p:cNvPr>
          <p:cNvSpPr/>
          <p:nvPr/>
        </p:nvSpPr>
        <p:spPr>
          <a:xfrm>
            <a:off x="1454046" y="155172"/>
            <a:ext cx="9293901" cy="4424855"/>
          </a:xfrm>
          <a:prstGeom prst="rect">
            <a:avLst/>
          </a:prstGeom>
          <a:solidFill>
            <a:srgbClr val="FFF7E7">
              <a:alpha val="2665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/>
          <p:cNvSpPr/>
          <p:nvPr/>
        </p:nvSpPr>
        <p:spPr>
          <a:xfrm>
            <a:off x="789708" y="5137275"/>
            <a:ext cx="10432473" cy="19082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Correlation between antibody assays and comparison between vaccine regimens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Correlation between antibody response to SARS-CoV-2 spike in patients with CLL after vaccination as measured from DBS eluate (TBS ELISA) or Roche assay on serum (Spearman’s rank (r=0.65; p&lt;0.0001). 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 Dot plot to show spike-specific antibody response in patients with CLL after first vaccination with either the BNT16b2 or ChAdOx1 vaccine as measured TBS ELISA on DBS eluates. 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sz="28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2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GB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 </a:t>
            </a:r>
            <a:endParaRPr lang="en-GB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8336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arry (School of Immunity and Infection)</dc:creator>
  <cp:lastModifiedBy>Helen Parry (School of Immunity and Infection)</cp:lastModifiedBy>
  <cp:revision>2</cp:revision>
  <dcterms:created xsi:type="dcterms:W3CDTF">2021-07-05T11:59:37Z</dcterms:created>
  <dcterms:modified xsi:type="dcterms:W3CDTF">2021-07-06T14:07:45Z</dcterms:modified>
</cp:coreProperties>
</file>